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  <p:sldMasterId id="2147483672" r:id="rId2"/>
  </p:sldMasterIdLst>
  <p:sldIdLst>
    <p:sldId id="639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4" d="100"/>
          <a:sy n="64" d="100"/>
        </p:scale>
        <p:origin x="1292" y="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1.xml"/><Relationship Id="rId7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372307357684187"/>
          <c:y val="5.4189997083697872E-2"/>
          <c:w val="0.81793225522134405"/>
          <c:h val="0.6762062554680664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O$3</c:f>
              <c:strCache>
                <c:ptCount val="1"/>
                <c:pt idx="0">
                  <c:v>Vehicl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R$4:$R$7</c:f>
                <c:numCache>
                  <c:formatCode>General</c:formatCode>
                  <c:ptCount val="4"/>
                  <c:pt idx="0">
                    <c:v>40.15</c:v>
                  </c:pt>
                  <c:pt idx="1">
                    <c:v>13.39</c:v>
                  </c:pt>
                  <c:pt idx="2">
                    <c:v>10.76</c:v>
                  </c:pt>
                  <c:pt idx="3">
                    <c:v>11.45</c:v>
                  </c:pt>
                </c:numCache>
              </c:numRef>
            </c:plus>
            <c:minus>
              <c:numRef>
                <c:f>Sheet1!$R$4:$R$7</c:f>
                <c:numCache>
                  <c:formatCode>General</c:formatCode>
                  <c:ptCount val="4"/>
                  <c:pt idx="0">
                    <c:v>40.15</c:v>
                  </c:pt>
                  <c:pt idx="1">
                    <c:v>13.39</c:v>
                  </c:pt>
                  <c:pt idx="2">
                    <c:v>10.76</c:v>
                  </c:pt>
                  <c:pt idx="3">
                    <c:v>11.4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N$4:$N$7</c:f>
              <c:strCache>
                <c:ptCount val="4"/>
                <c:pt idx="0">
                  <c:v>pMek/Mek</c:v>
                </c:pt>
                <c:pt idx="1">
                  <c:v>pAkt (S473)/Akt</c:v>
                </c:pt>
                <c:pt idx="2">
                  <c:v>pAkt (T308)/Akt</c:v>
                </c:pt>
                <c:pt idx="3">
                  <c:v>pS6/S6</c:v>
                </c:pt>
              </c:strCache>
            </c:strRef>
          </c:cat>
          <c:val>
            <c:numRef>
              <c:f>Sheet1!$O$4:$O$7</c:f>
              <c:numCache>
                <c:formatCode>0</c:formatCode>
                <c:ptCount val="4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A9A-4FE9-88BB-7736F3C2BE84}"/>
            </c:ext>
          </c:extLst>
        </c:ser>
        <c:ser>
          <c:idx val="1"/>
          <c:order val="1"/>
          <c:tx>
            <c:strRef>
              <c:f>Sheet1!$P$3</c:f>
              <c:strCache>
                <c:ptCount val="1"/>
                <c:pt idx="0">
                  <c:v>KRB456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S$4:$S$7</c:f>
                <c:numCache>
                  <c:formatCode>General</c:formatCode>
                  <c:ptCount val="4"/>
                  <c:pt idx="0">
                    <c:v>20.67</c:v>
                  </c:pt>
                  <c:pt idx="1">
                    <c:v>19.41</c:v>
                  </c:pt>
                  <c:pt idx="2">
                    <c:v>16.28</c:v>
                  </c:pt>
                  <c:pt idx="3">
                    <c:v>8.9600000000000009</c:v>
                  </c:pt>
                </c:numCache>
              </c:numRef>
            </c:plus>
            <c:minus>
              <c:numRef>
                <c:f>Sheet1!$S$4:$S$7</c:f>
                <c:numCache>
                  <c:formatCode>General</c:formatCode>
                  <c:ptCount val="4"/>
                  <c:pt idx="0">
                    <c:v>20.67</c:v>
                  </c:pt>
                  <c:pt idx="1">
                    <c:v>19.41</c:v>
                  </c:pt>
                  <c:pt idx="2">
                    <c:v>16.28</c:v>
                  </c:pt>
                  <c:pt idx="3">
                    <c:v>8.960000000000000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N$4:$N$7</c:f>
              <c:strCache>
                <c:ptCount val="4"/>
                <c:pt idx="0">
                  <c:v>pMek/Mek</c:v>
                </c:pt>
                <c:pt idx="1">
                  <c:v>pAkt (S473)/Akt</c:v>
                </c:pt>
                <c:pt idx="2">
                  <c:v>pAkt (T308)/Akt</c:v>
                </c:pt>
                <c:pt idx="3">
                  <c:v>pS6/S6</c:v>
                </c:pt>
              </c:strCache>
            </c:strRef>
          </c:cat>
          <c:val>
            <c:numRef>
              <c:f>Sheet1!$P$4:$P$7</c:f>
              <c:numCache>
                <c:formatCode>0.00</c:formatCode>
                <c:ptCount val="4"/>
                <c:pt idx="0" formatCode="General">
                  <c:v>50.06</c:v>
                </c:pt>
                <c:pt idx="1">
                  <c:v>26.55</c:v>
                </c:pt>
                <c:pt idx="2">
                  <c:v>43.34</c:v>
                </c:pt>
                <c:pt idx="3">
                  <c:v>16.05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A9A-4FE9-88BB-7736F3C2BE8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49740543"/>
        <c:axId val="1704612559"/>
      </c:barChart>
      <c:catAx>
        <c:axId val="1549740543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04612559"/>
        <c:crosses val="autoZero"/>
        <c:auto val="1"/>
        <c:lblAlgn val="ctr"/>
        <c:lblOffset val="100"/>
        <c:noMultiLvlLbl val="0"/>
      </c:catAx>
      <c:valAx>
        <c:axId val="1704612559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 b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% Chang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49740543"/>
        <c:crosses val="autoZero"/>
        <c:crossBetween val="between"/>
        <c:majorUnit val="25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4282382721640314"/>
          <c:y val="9.8374161563137934E-3"/>
          <c:w val="0.41147311943149967"/>
          <c:h val="9.664406532516767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421984251968503"/>
          <c:y val="0.12962962962962962"/>
          <c:w val="0.85522456692913396"/>
          <c:h val="0.7172528433945757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O$30</c:f>
              <c:strCache>
                <c:ptCount val="1"/>
                <c:pt idx="0">
                  <c:v>Vehicl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R$31:$R$33</c:f>
                <c:numCache>
                  <c:formatCode>General</c:formatCode>
                  <c:ptCount val="3"/>
                  <c:pt idx="0">
                    <c:v>0.04</c:v>
                  </c:pt>
                  <c:pt idx="1">
                    <c:v>0.27</c:v>
                  </c:pt>
                  <c:pt idx="2">
                    <c:v>0.4</c:v>
                  </c:pt>
                </c:numCache>
              </c:numRef>
            </c:plus>
            <c:minus>
              <c:numRef>
                <c:f>Sheet1!$R$31:$R$33</c:f>
                <c:numCache>
                  <c:formatCode>General</c:formatCode>
                  <c:ptCount val="3"/>
                  <c:pt idx="0">
                    <c:v>0.04</c:v>
                  </c:pt>
                  <c:pt idx="1">
                    <c:v>0.27</c:v>
                  </c:pt>
                  <c:pt idx="2">
                    <c:v>0.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N$31:$N$33</c:f>
              <c:strCache>
                <c:ptCount val="3"/>
                <c:pt idx="0">
                  <c:v>pErk/Erk</c:v>
                </c:pt>
                <c:pt idx="1">
                  <c:v>c-Casp3/Vinculin</c:v>
                </c:pt>
                <c:pt idx="2">
                  <c:v>c-PARP/Vinculin</c:v>
                </c:pt>
              </c:strCache>
            </c:strRef>
          </c:cat>
          <c:val>
            <c:numRef>
              <c:f>Sheet1!$O$31:$O$33</c:f>
              <c:numCache>
                <c:formatCode>0.00</c:formatCode>
                <c:ptCount val="3"/>
                <c:pt idx="0">
                  <c:v>1</c:v>
                </c:pt>
                <c:pt idx="1">
                  <c:v>1</c:v>
                </c:pt>
                <c:pt idx="2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6ED-4C5B-ADDC-AA32AEAB1736}"/>
            </c:ext>
          </c:extLst>
        </c:ser>
        <c:ser>
          <c:idx val="1"/>
          <c:order val="1"/>
          <c:tx>
            <c:strRef>
              <c:f>Sheet1!$P$30</c:f>
              <c:strCache>
                <c:ptCount val="1"/>
                <c:pt idx="0">
                  <c:v>KRB456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S$31:$S$33</c:f>
                <c:numCache>
                  <c:formatCode>General</c:formatCode>
                  <c:ptCount val="3"/>
                  <c:pt idx="0">
                    <c:v>0.04</c:v>
                  </c:pt>
                  <c:pt idx="1">
                    <c:v>0.48</c:v>
                  </c:pt>
                  <c:pt idx="2">
                    <c:v>1.04</c:v>
                  </c:pt>
                </c:numCache>
              </c:numRef>
            </c:plus>
            <c:minus>
              <c:numRef>
                <c:f>Sheet1!$S$31:$S$33</c:f>
                <c:numCache>
                  <c:formatCode>General</c:formatCode>
                  <c:ptCount val="3"/>
                  <c:pt idx="0">
                    <c:v>0.04</c:v>
                  </c:pt>
                  <c:pt idx="1">
                    <c:v>0.48</c:v>
                  </c:pt>
                  <c:pt idx="2">
                    <c:v>1.0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N$31:$N$33</c:f>
              <c:strCache>
                <c:ptCount val="3"/>
                <c:pt idx="0">
                  <c:v>pErk/Erk</c:v>
                </c:pt>
                <c:pt idx="1">
                  <c:v>c-Casp3/Vinculin</c:v>
                </c:pt>
                <c:pt idx="2">
                  <c:v>c-PARP/Vinculin</c:v>
                </c:pt>
              </c:strCache>
            </c:strRef>
          </c:cat>
          <c:val>
            <c:numRef>
              <c:f>Sheet1!$P$31:$P$33</c:f>
              <c:numCache>
                <c:formatCode>0.00</c:formatCode>
                <c:ptCount val="3"/>
                <c:pt idx="0">
                  <c:v>1.23</c:v>
                </c:pt>
                <c:pt idx="1">
                  <c:v>3.09</c:v>
                </c:pt>
                <c:pt idx="2">
                  <c:v>2.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6ED-4C5B-ADDC-AA32AEAB173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41344367"/>
        <c:axId val="1740199775"/>
      </c:barChart>
      <c:catAx>
        <c:axId val="1741344367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40199775"/>
        <c:crosses val="autoZero"/>
        <c:auto val="1"/>
        <c:lblAlgn val="ctr"/>
        <c:lblOffset val="100"/>
        <c:noMultiLvlLbl val="0"/>
      </c:catAx>
      <c:valAx>
        <c:axId val="174019977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 b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old Increase</a:t>
                </a:r>
              </a:p>
            </c:rich>
          </c:tx>
          <c:layout>
            <c:manualLayout>
              <c:xMode val="edge"/>
              <c:yMode val="edge"/>
              <c:x val="2.208223972003499E-3"/>
              <c:y val="0.3104319772528433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41344367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6039001618304212"/>
          <c:y val="2.3726305045202681E-2"/>
          <c:w val="0.38362493649332796"/>
          <c:h val="9.664406532516767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62A69-21FA-4FF4-9808-4DFF8298D8B6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6A660-AF81-464A-AAE5-5E82323FD6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98157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62A69-21FA-4FF4-9808-4DFF8298D8B6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6A660-AF81-464A-AAE5-5E82323FD6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88568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62A69-21FA-4FF4-9808-4DFF8298D8B6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6A660-AF81-464A-AAE5-5E82323FD6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1359154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9" indent="0" algn="ctr">
              <a:buNone/>
              <a:defRPr sz="2000"/>
            </a:lvl2pPr>
            <a:lvl3pPr marL="914377" indent="0" algn="ctr">
              <a:buNone/>
              <a:defRPr sz="1800"/>
            </a:lvl3pPr>
            <a:lvl4pPr marL="1371566" indent="0" algn="ctr">
              <a:buNone/>
              <a:defRPr sz="1600"/>
            </a:lvl4pPr>
            <a:lvl5pPr marL="1828754" indent="0" algn="ctr">
              <a:buNone/>
              <a:defRPr sz="1600"/>
            </a:lvl5pPr>
            <a:lvl6pPr marL="2285943" indent="0" algn="ctr">
              <a:buNone/>
              <a:defRPr sz="1600"/>
            </a:lvl6pPr>
            <a:lvl7pPr marL="2743131" indent="0" algn="ctr">
              <a:buNone/>
              <a:defRPr sz="1600"/>
            </a:lvl7pPr>
            <a:lvl8pPr marL="3200320" indent="0" algn="ctr">
              <a:buNone/>
              <a:defRPr sz="1600"/>
            </a:lvl8pPr>
            <a:lvl9pPr marL="3657509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293558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5792236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43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8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189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77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13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9944747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3088049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9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2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2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4771575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91291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6177029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30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58746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62A69-21FA-4FF4-9808-4DFF8298D8B6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6A660-AF81-464A-AAE5-5E82323FD6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2451013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30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1448039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0307724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2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53386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62A69-21FA-4FF4-9808-4DFF8298D8B6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6A660-AF81-464A-AAE5-5E82323FD6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75890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62A69-21FA-4FF4-9808-4DFF8298D8B6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6A660-AF81-464A-AAE5-5E82323FD6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63372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62A69-21FA-4FF4-9808-4DFF8298D8B6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6A660-AF81-464A-AAE5-5E82323FD6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39290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62A69-21FA-4FF4-9808-4DFF8298D8B6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6A660-AF81-464A-AAE5-5E82323FD6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89790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62A69-21FA-4FF4-9808-4DFF8298D8B6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6A660-AF81-464A-AAE5-5E82323FD6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81186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62A69-21FA-4FF4-9808-4DFF8298D8B6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6A660-AF81-464A-AAE5-5E82323FD6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32248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62A69-21FA-4FF4-9808-4DFF8298D8B6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6A660-AF81-464A-AAE5-5E82323FD6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55946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B62A69-21FA-4FF4-9808-4DFF8298D8B6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06A660-AF81-464A-AAE5-5E82323FD6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22704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9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5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5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5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73435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377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4" indent="-228594" algn="l" defTabSz="914377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8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1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9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18" Type="http://schemas.microsoft.com/office/2007/relationships/hdphoto" Target="../media/hdphoto8.wdp"/><Relationship Id="rId26" Type="http://schemas.openxmlformats.org/officeDocument/2006/relationships/image" Target="../media/image14.png"/><Relationship Id="rId3" Type="http://schemas.microsoft.com/office/2007/relationships/hdphoto" Target="../media/hdphoto1.wdp"/><Relationship Id="rId21" Type="http://schemas.openxmlformats.org/officeDocument/2006/relationships/image" Target="../media/image11.png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openxmlformats.org/officeDocument/2006/relationships/image" Target="../media/image9.png"/><Relationship Id="rId25" Type="http://schemas.microsoft.com/office/2007/relationships/hdphoto" Target="../media/hdphoto11.wdp"/><Relationship Id="rId2" Type="http://schemas.openxmlformats.org/officeDocument/2006/relationships/image" Target="../media/image1.png"/><Relationship Id="rId16" Type="http://schemas.microsoft.com/office/2007/relationships/hdphoto" Target="../media/hdphoto7.wdp"/><Relationship Id="rId20" Type="http://schemas.microsoft.com/office/2007/relationships/hdphoto" Target="../media/hdphoto9.wdp"/><Relationship Id="rId29" Type="http://schemas.microsoft.com/office/2007/relationships/hdphoto" Target="../media/hdphoto13.wdp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24" Type="http://schemas.openxmlformats.org/officeDocument/2006/relationships/image" Target="../media/image13.png"/><Relationship Id="rId5" Type="http://schemas.microsoft.com/office/2007/relationships/hdphoto" Target="../media/hdphoto2.wdp"/><Relationship Id="rId15" Type="http://schemas.openxmlformats.org/officeDocument/2006/relationships/image" Target="../media/image8.png"/><Relationship Id="rId23" Type="http://schemas.microsoft.com/office/2007/relationships/hdphoto" Target="../media/hdphoto10.wdp"/><Relationship Id="rId28" Type="http://schemas.openxmlformats.org/officeDocument/2006/relationships/image" Target="../media/image15.png"/><Relationship Id="rId10" Type="http://schemas.openxmlformats.org/officeDocument/2006/relationships/image" Target="../media/image5.png"/><Relationship Id="rId19" Type="http://schemas.openxmlformats.org/officeDocument/2006/relationships/image" Target="../media/image10.png"/><Relationship Id="rId31" Type="http://schemas.openxmlformats.org/officeDocument/2006/relationships/chart" Target="../charts/chart2.xml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Relationship Id="rId22" Type="http://schemas.openxmlformats.org/officeDocument/2006/relationships/image" Target="../media/image12.png"/><Relationship Id="rId27" Type="http://schemas.microsoft.com/office/2007/relationships/hdphoto" Target="../media/hdphoto12.wdp"/><Relationship Id="rId30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Rectangle 48">
            <a:extLst>
              <a:ext uri="{FF2B5EF4-FFF2-40B4-BE49-F238E27FC236}">
                <a16:creationId xmlns:a16="http://schemas.microsoft.com/office/drawing/2014/main" id="{5ECCB357-9F9D-43FF-A139-61482F12A481}"/>
              </a:ext>
            </a:extLst>
          </p:cNvPr>
          <p:cNvSpPr/>
          <p:nvPr/>
        </p:nvSpPr>
        <p:spPr>
          <a:xfrm>
            <a:off x="195189" y="242766"/>
            <a:ext cx="105028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igure S9 </a:t>
            </a:r>
            <a:endParaRPr kumimoji="0" lang="en-US" sz="14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859F167F-F129-4E98-8916-0F1DE389109B}"/>
              </a:ext>
            </a:extLst>
          </p:cNvPr>
          <p:cNvGrpSpPr/>
          <p:nvPr/>
        </p:nvGrpSpPr>
        <p:grpSpPr>
          <a:xfrm>
            <a:off x="607699" y="717454"/>
            <a:ext cx="8183062" cy="5723983"/>
            <a:chOff x="607699" y="717454"/>
            <a:chExt cx="8183062" cy="5723983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2151C847-EB3C-43F5-A22E-ADF0DA25CB7B}"/>
                </a:ext>
              </a:extLst>
            </p:cNvPr>
            <p:cNvGrpSpPr/>
            <p:nvPr/>
          </p:nvGrpSpPr>
          <p:grpSpPr>
            <a:xfrm>
              <a:off x="607699" y="717454"/>
              <a:ext cx="8183062" cy="5723983"/>
              <a:chOff x="607699" y="717454"/>
              <a:chExt cx="8183062" cy="5723983"/>
            </a:xfrm>
          </p:grpSpPr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5FAD9D8B-2F52-46B9-B128-EBAFE52C15BD}"/>
                  </a:ext>
                </a:extLst>
              </p:cNvPr>
              <p:cNvSpPr txBox="1"/>
              <p:nvPr/>
            </p:nvSpPr>
            <p:spPr>
              <a:xfrm>
                <a:off x="1817718" y="967328"/>
                <a:ext cx="39839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68578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   V1           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0E3891B5-231B-49F1-8B71-B66F17F7EF30}"/>
                  </a:ext>
                </a:extLst>
              </p:cNvPr>
              <p:cNvSpPr txBox="1"/>
              <p:nvPr/>
            </p:nvSpPr>
            <p:spPr>
              <a:xfrm>
                <a:off x="2131222" y="962175"/>
                <a:ext cx="461665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68578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   V2           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3C263B8F-36B3-4DF1-86B9-56319327F7AC}"/>
                  </a:ext>
                </a:extLst>
              </p:cNvPr>
              <p:cNvSpPr txBox="1"/>
              <p:nvPr/>
            </p:nvSpPr>
            <p:spPr>
              <a:xfrm>
                <a:off x="2405229" y="952020"/>
                <a:ext cx="461666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68578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   V3           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BF59EA0F-8FEC-4C48-9A24-298A67794C98}"/>
                  </a:ext>
                </a:extLst>
              </p:cNvPr>
              <p:cNvSpPr txBox="1"/>
              <p:nvPr/>
            </p:nvSpPr>
            <p:spPr>
              <a:xfrm rot="16200000">
                <a:off x="2444859" y="882421"/>
                <a:ext cx="646332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68578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   KRB1          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8C2E93EB-1247-46C9-AA4B-C1ECD03B08F6}"/>
                  </a:ext>
                </a:extLst>
              </p:cNvPr>
              <p:cNvSpPr txBox="1"/>
              <p:nvPr/>
            </p:nvSpPr>
            <p:spPr>
              <a:xfrm rot="16200000">
                <a:off x="2725264" y="887658"/>
                <a:ext cx="64993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68578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   KRB2           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FE3C5025-8E70-4EF8-B6CC-E36C597DAF84}"/>
                  </a:ext>
                </a:extLst>
              </p:cNvPr>
              <p:cNvSpPr txBox="1"/>
              <p:nvPr/>
            </p:nvSpPr>
            <p:spPr>
              <a:xfrm rot="16200000">
                <a:off x="3042508" y="887017"/>
                <a:ext cx="646334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68578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   KRB3           </a:t>
                </a:r>
              </a:p>
            </p:txBody>
          </p:sp>
          <p:pic>
            <p:nvPicPr>
              <p:cNvPr id="14" name="Picture 13">
                <a:extLst>
                  <a:ext uri="{FF2B5EF4-FFF2-40B4-BE49-F238E27FC236}">
                    <a16:creationId xmlns:a16="http://schemas.microsoft.com/office/drawing/2014/main" id="{F945D080-B7A8-4BFC-80C0-C8F748B34817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805214" y="1405048"/>
                <a:ext cx="1828800" cy="301752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DE884B00-FCF9-40CE-ADFC-2DE83758BE8B}"/>
                  </a:ext>
                </a:extLst>
              </p:cNvPr>
              <p:cNvSpPr txBox="1"/>
              <p:nvPr/>
            </p:nvSpPr>
            <p:spPr>
              <a:xfrm>
                <a:off x="861252" y="1433091"/>
                <a:ext cx="85792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68578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pMEK</a:t>
                </a:r>
                <a:r>
                  <a:rPr kumimoji="0" 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****</a:t>
                </a:r>
                <a:endPara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pic>
            <p:nvPicPr>
              <p:cNvPr id="16" name="Picture 15">
                <a:extLst>
                  <a:ext uri="{FF2B5EF4-FFF2-40B4-BE49-F238E27FC236}">
                    <a16:creationId xmlns:a16="http://schemas.microsoft.com/office/drawing/2014/main" id="{41B016F7-4528-4C23-BDF6-ED96833D46E2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802662" y="1739773"/>
                <a:ext cx="1828800" cy="301752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F90D3CEA-DBE0-48E9-9594-A512D120C0FD}"/>
                  </a:ext>
                </a:extLst>
              </p:cNvPr>
              <p:cNvSpPr txBox="1"/>
              <p:nvPr/>
            </p:nvSpPr>
            <p:spPr>
              <a:xfrm>
                <a:off x="918685" y="1756127"/>
                <a:ext cx="54213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68578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Mek</a:t>
                </a:r>
                <a:r>
                  <a:rPr kumimoji="0" 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*</a:t>
                </a:r>
                <a:endPara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6FBD0B90-A405-466B-A3F3-9E2C9DDEF5EE}"/>
                  </a:ext>
                </a:extLst>
              </p:cNvPr>
              <p:cNvSpPr txBox="1"/>
              <p:nvPr/>
            </p:nvSpPr>
            <p:spPr>
              <a:xfrm>
                <a:off x="857371" y="2090881"/>
                <a:ext cx="64472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68578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pErk</a:t>
                </a:r>
                <a:r>
                  <a:rPr kumimoji="0" 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**</a:t>
                </a:r>
                <a:endPara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pic>
            <p:nvPicPr>
              <p:cNvPr id="19" name="Picture 18">
                <a:extLst>
                  <a:ext uri="{FF2B5EF4-FFF2-40B4-BE49-F238E27FC236}">
                    <a16:creationId xmlns:a16="http://schemas.microsoft.com/office/drawing/2014/main" id="{EB8402FC-BE16-4454-8457-16C52726D2CF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801083" y="2066587"/>
                <a:ext cx="1828800" cy="301752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20" name="Picture 19">
                <a:extLst>
                  <a:ext uri="{FF2B5EF4-FFF2-40B4-BE49-F238E27FC236}">
                    <a16:creationId xmlns:a16="http://schemas.microsoft.com/office/drawing/2014/main" id="{15B6C30F-D116-4025-9727-3589556EDEB6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8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805817" y="2401627"/>
                <a:ext cx="1828800" cy="301752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73FDE6D3-A86A-4D52-AAFB-6952B2CFD557}"/>
                  </a:ext>
                </a:extLst>
              </p:cNvPr>
              <p:cNvSpPr txBox="1"/>
              <p:nvPr/>
            </p:nvSpPr>
            <p:spPr>
              <a:xfrm>
                <a:off x="910437" y="2447214"/>
                <a:ext cx="71205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68578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Erk</a:t>
                </a:r>
                <a:r>
                  <a:rPr kumimoji="0" 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 ****</a:t>
                </a:r>
                <a:endPara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pic>
            <p:nvPicPr>
              <p:cNvPr id="22" name="Picture 21">
                <a:extLst>
                  <a:ext uri="{FF2B5EF4-FFF2-40B4-BE49-F238E27FC236}">
                    <a16:creationId xmlns:a16="http://schemas.microsoft.com/office/drawing/2014/main" id="{C44CD4D1-30F9-44E2-B6D2-A996B51D1900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0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803497" y="2737685"/>
                <a:ext cx="1828800" cy="301752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9F8E23EF-D7CA-478D-876A-3FC0E517D8CD}"/>
                  </a:ext>
                </a:extLst>
              </p:cNvPr>
              <p:cNvSpPr txBox="1"/>
              <p:nvPr/>
            </p:nvSpPr>
            <p:spPr>
              <a:xfrm>
                <a:off x="639569" y="2727030"/>
                <a:ext cx="10887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68578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pAkt</a:t>
                </a:r>
                <a:r>
                  <a:rPr kumimoji="0" 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 (S473)*</a:t>
                </a:r>
                <a:endPara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pic>
            <p:nvPicPr>
              <p:cNvPr id="24" name="Picture 23">
                <a:extLst>
                  <a:ext uri="{FF2B5EF4-FFF2-40B4-BE49-F238E27FC236}">
                    <a16:creationId xmlns:a16="http://schemas.microsoft.com/office/drawing/2014/main" id="{6BB13062-D04F-4D71-8D6A-BCD87F03C0F1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2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800795" y="3069048"/>
                <a:ext cx="1828800" cy="301752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53A1AE2B-1FBC-43C1-8CE5-5859F2451C68}"/>
                  </a:ext>
                </a:extLst>
              </p:cNvPr>
              <p:cNvSpPr txBox="1"/>
              <p:nvPr/>
            </p:nvSpPr>
            <p:spPr>
              <a:xfrm>
                <a:off x="620270" y="3087833"/>
                <a:ext cx="125867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68578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pAkt</a:t>
                </a:r>
                <a:r>
                  <a:rPr kumimoji="0" 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 (T308)****</a:t>
                </a:r>
                <a:endPara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pic>
            <p:nvPicPr>
              <p:cNvPr id="26" name="Picture 25">
                <a:extLst>
                  <a:ext uri="{FF2B5EF4-FFF2-40B4-BE49-F238E27FC236}">
                    <a16:creationId xmlns:a16="http://schemas.microsoft.com/office/drawing/2014/main" id="{19025053-06E2-41C9-BAF9-A8B765958EC0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1800859" y="3401152"/>
                <a:ext cx="1828800" cy="301752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BD48683A-9132-47D7-90BB-9213333D9732}"/>
                  </a:ext>
                </a:extLst>
              </p:cNvPr>
              <p:cNvSpPr txBox="1"/>
              <p:nvPr/>
            </p:nvSpPr>
            <p:spPr>
              <a:xfrm>
                <a:off x="914374" y="3420652"/>
                <a:ext cx="6094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68578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Akt</a:t>
                </a:r>
                <a:r>
                  <a:rPr kumimoji="0" 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***</a:t>
                </a:r>
                <a:endPara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pic>
            <p:nvPicPr>
              <p:cNvPr id="28" name="Picture 27">
                <a:extLst>
                  <a:ext uri="{FF2B5EF4-FFF2-40B4-BE49-F238E27FC236}">
                    <a16:creationId xmlns:a16="http://schemas.microsoft.com/office/drawing/2014/main" id="{E5803162-6415-45A7-811E-C5F2D3983253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5">
                <a:extLst>
                  <a:ext uri="{BEBA8EAE-BF5A-486C-A8C5-ECC9F3942E4B}">
                    <a14:imgProps xmlns:a14="http://schemas.microsoft.com/office/drawing/2010/main">
                      <a14:imgLayer r:embed="rId16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805817" y="3734617"/>
                <a:ext cx="1828800" cy="301752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81E3F74B-2E88-44F5-9133-CF12E7FC4878}"/>
                  </a:ext>
                </a:extLst>
              </p:cNvPr>
              <p:cNvSpPr txBox="1"/>
              <p:nvPr/>
            </p:nvSpPr>
            <p:spPr>
              <a:xfrm>
                <a:off x="854185" y="3723880"/>
                <a:ext cx="5261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68578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pS6*</a:t>
                </a:r>
                <a:endPara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pic>
            <p:nvPicPr>
              <p:cNvPr id="30" name="Picture 29">
                <a:extLst>
                  <a:ext uri="{FF2B5EF4-FFF2-40B4-BE49-F238E27FC236}">
                    <a16:creationId xmlns:a16="http://schemas.microsoft.com/office/drawing/2014/main" id="{7BA00A2A-14CD-4DD5-89FA-E7FDE3FEE718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7">
                <a:extLst>
                  <a:ext uri="{BEBA8EAE-BF5A-486C-A8C5-ECC9F3942E4B}">
                    <a14:imgProps xmlns:a14="http://schemas.microsoft.com/office/drawing/2010/main">
                      <a14:imgLayer r:embed="rId18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805817" y="4063708"/>
                <a:ext cx="1828800" cy="301752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91BB4861-79DB-4967-99DC-7467C2CA1C42}"/>
                  </a:ext>
                </a:extLst>
              </p:cNvPr>
              <p:cNvSpPr txBox="1"/>
              <p:nvPr/>
            </p:nvSpPr>
            <p:spPr>
              <a:xfrm>
                <a:off x="915583" y="4070347"/>
                <a:ext cx="49084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68578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S6**</a:t>
                </a:r>
                <a:endPara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pic>
            <p:nvPicPr>
              <p:cNvPr id="32" name="Picture 31">
                <a:extLst>
                  <a:ext uri="{FF2B5EF4-FFF2-40B4-BE49-F238E27FC236}">
                    <a16:creationId xmlns:a16="http://schemas.microsoft.com/office/drawing/2014/main" id="{DB8A677C-A8DC-4376-98AD-8C85D00C195C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9">
                <a:extLst>
                  <a:ext uri="{BEBA8EAE-BF5A-486C-A8C5-ECC9F3942E4B}">
                    <a14:imgProps xmlns:a14="http://schemas.microsoft.com/office/drawing/2010/main">
                      <a14:imgLayer r:embed="rId20">
                        <a14:imgEffect>
                          <a14:brightnessContrast bright="-5000" contrast="2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805817" y="4391671"/>
                <a:ext cx="1828800" cy="301752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1C8ACEEE-4E8C-4E14-92D3-D669B1B744DE}"/>
                  </a:ext>
                </a:extLst>
              </p:cNvPr>
              <p:cNvSpPr txBox="1"/>
              <p:nvPr/>
            </p:nvSpPr>
            <p:spPr>
              <a:xfrm>
                <a:off x="760084" y="4389673"/>
                <a:ext cx="89159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68578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cCasp3 **</a:t>
                </a:r>
                <a:endPara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pic>
            <p:nvPicPr>
              <p:cNvPr id="34" name="Picture 33">
                <a:extLst>
                  <a:ext uri="{FF2B5EF4-FFF2-40B4-BE49-F238E27FC236}">
                    <a16:creationId xmlns:a16="http://schemas.microsoft.com/office/drawing/2014/main" id="{DF5DBCE9-6797-416E-80DB-5750DA4221EB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1"/>
              <a:stretch>
                <a:fillRect/>
              </a:stretch>
            </p:blipFill>
            <p:spPr>
              <a:xfrm>
                <a:off x="1803497" y="4719928"/>
                <a:ext cx="1828800" cy="301752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57F75B3F-7BE9-40CA-B62F-FD23806463DB}"/>
                  </a:ext>
                </a:extLst>
              </p:cNvPr>
              <p:cNvSpPr txBox="1"/>
              <p:nvPr/>
            </p:nvSpPr>
            <p:spPr>
              <a:xfrm>
                <a:off x="749597" y="4723269"/>
                <a:ext cx="96237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68578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cPARP</a:t>
                </a:r>
                <a:r>
                  <a:rPr kumimoji="0" 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 ****</a:t>
                </a:r>
                <a:endPara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pic>
            <p:nvPicPr>
              <p:cNvPr id="36" name="Picture 35">
                <a:extLst>
                  <a:ext uri="{FF2B5EF4-FFF2-40B4-BE49-F238E27FC236}">
                    <a16:creationId xmlns:a16="http://schemas.microsoft.com/office/drawing/2014/main" id="{1B456423-F5BA-4598-879E-36A7336E61DD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2">
                <a:extLst>
                  <a:ext uri="{BEBA8EAE-BF5A-486C-A8C5-ECC9F3942E4B}">
                    <a14:imgProps xmlns:a14="http://schemas.microsoft.com/office/drawing/2010/main">
                      <a14:imgLayer r:embed="rId23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804422" y="6047747"/>
                <a:ext cx="1828800" cy="301752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BE7BB52A-04EB-4BEB-9089-C1F5D9D76463}"/>
                  </a:ext>
                </a:extLst>
              </p:cNvPr>
              <p:cNvSpPr txBox="1"/>
              <p:nvPr/>
            </p:nvSpPr>
            <p:spPr>
              <a:xfrm>
                <a:off x="740741" y="6032924"/>
                <a:ext cx="102027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68578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Vinculin****</a:t>
                </a:r>
                <a:endPara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pic>
            <p:nvPicPr>
              <p:cNvPr id="38" name="Picture 37">
                <a:extLst>
                  <a:ext uri="{FF2B5EF4-FFF2-40B4-BE49-F238E27FC236}">
                    <a16:creationId xmlns:a16="http://schemas.microsoft.com/office/drawing/2014/main" id="{DF9FF34C-25CD-49D4-9C43-1E3DE897B6AB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4">
                <a:extLst>
                  <a:ext uri="{BEBA8EAE-BF5A-486C-A8C5-ECC9F3942E4B}">
                    <a14:imgProps xmlns:a14="http://schemas.microsoft.com/office/drawing/2010/main">
                      <a14:imgLayer r:embed="rId25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804305" y="5715100"/>
                <a:ext cx="1828800" cy="301752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BCC4DBB0-0F01-4952-9BDE-B55B63E5A6D5}"/>
                  </a:ext>
                </a:extLst>
              </p:cNvPr>
              <p:cNvSpPr txBox="1"/>
              <p:nvPr/>
            </p:nvSpPr>
            <p:spPr>
              <a:xfrm>
                <a:off x="754493" y="5703433"/>
                <a:ext cx="96096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68578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Vinculin***</a:t>
                </a:r>
                <a:endPara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pic>
            <p:nvPicPr>
              <p:cNvPr id="40" name="Picture 39">
                <a:extLst>
                  <a:ext uri="{FF2B5EF4-FFF2-40B4-BE49-F238E27FC236}">
                    <a16:creationId xmlns:a16="http://schemas.microsoft.com/office/drawing/2014/main" id="{8AAFCD42-D55C-4BAB-A43B-C23DAB1E8C64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6">
                <a:extLst>
                  <a:ext uri="{BEBA8EAE-BF5A-486C-A8C5-ECC9F3942E4B}">
                    <a14:imgProps xmlns:a14="http://schemas.microsoft.com/office/drawing/2010/main">
                      <a14:imgLayer r:embed="rId27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807090" y="5383884"/>
                <a:ext cx="1828800" cy="301752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3A5561B7-EF9C-44AA-B690-1F8449DAC68B}"/>
                  </a:ext>
                </a:extLst>
              </p:cNvPr>
              <p:cNvSpPr txBox="1"/>
              <p:nvPr/>
            </p:nvSpPr>
            <p:spPr>
              <a:xfrm>
                <a:off x="754370" y="5358288"/>
                <a:ext cx="90165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68578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Vinculin**</a:t>
                </a:r>
                <a:endPara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pic>
            <p:nvPicPr>
              <p:cNvPr id="42" name="Picture 41">
                <a:extLst>
                  <a:ext uri="{FF2B5EF4-FFF2-40B4-BE49-F238E27FC236}">
                    <a16:creationId xmlns:a16="http://schemas.microsoft.com/office/drawing/2014/main" id="{869694E9-0514-4035-A08E-12B7D7EB0433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8">
                <a:extLst>
                  <a:ext uri="{BEBA8EAE-BF5A-486C-A8C5-ECC9F3942E4B}">
                    <a14:imgProps xmlns:a14="http://schemas.microsoft.com/office/drawing/2010/main">
                      <a14:imgLayer r:embed="rId29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807559" y="5047510"/>
                <a:ext cx="1828800" cy="301752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F43B2553-E444-40E3-A769-814EE1999516}"/>
                  </a:ext>
                </a:extLst>
              </p:cNvPr>
              <p:cNvSpPr txBox="1"/>
              <p:nvPr/>
            </p:nvSpPr>
            <p:spPr>
              <a:xfrm>
                <a:off x="759345" y="5034339"/>
                <a:ext cx="84234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68578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Vinculin*</a:t>
                </a:r>
                <a:endPara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90" name="Rectangle 89">
                <a:extLst>
                  <a:ext uri="{FF2B5EF4-FFF2-40B4-BE49-F238E27FC236}">
                    <a16:creationId xmlns:a16="http://schemas.microsoft.com/office/drawing/2014/main" id="{35EC5062-16D1-4C1F-9CEE-38A2B2BDA3F8}"/>
                  </a:ext>
                </a:extLst>
              </p:cNvPr>
              <p:cNvSpPr/>
              <p:nvPr/>
            </p:nvSpPr>
            <p:spPr>
              <a:xfrm>
                <a:off x="607699" y="717454"/>
                <a:ext cx="3103503" cy="5723983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91" name="Rectangle 90">
                <a:extLst>
                  <a:ext uri="{FF2B5EF4-FFF2-40B4-BE49-F238E27FC236}">
                    <a16:creationId xmlns:a16="http://schemas.microsoft.com/office/drawing/2014/main" id="{919BCF9F-3736-45E5-8ADA-CC5F9C607ED3}"/>
                  </a:ext>
                </a:extLst>
              </p:cNvPr>
              <p:cNvSpPr/>
              <p:nvPr/>
            </p:nvSpPr>
            <p:spPr>
              <a:xfrm>
                <a:off x="3780602" y="717454"/>
                <a:ext cx="5010159" cy="5723983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graphicFrame>
            <p:nvGraphicFramePr>
              <p:cNvPr id="48" name="Chart 47">
                <a:extLst>
                  <a:ext uri="{FF2B5EF4-FFF2-40B4-BE49-F238E27FC236}">
                    <a16:creationId xmlns:a16="http://schemas.microsoft.com/office/drawing/2014/main" id="{C67E4504-4B67-47F3-88CF-D4075384C31E}"/>
                  </a:ext>
                </a:extLst>
              </p:cNvPr>
              <p:cNvGraphicFramePr>
                <a:graphicFrameLocks/>
              </p:cNvGraphicFramePr>
              <p:nvPr>
                <p:extLst/>
              </p:nvPr>
            </p:nvGraphicFramePr>
            <p:xfrm>
              <a:off x="3802386" y="808828"/>
              <a:ext cx="4928616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0"/>
              </a:graphicData>
            </a:graphic>
          </p:graphicFrame>
          <p:graphicFrame>
            <p:nvGraphicFramePr>
              <p:cNvPr id="54" name="Chart 53">
                <a:extLst>
                  <a:ext uri="{FF2B5EF4-FFF2-40B4-BE49-F238E27FC236}">
                    <a16:creationId xmlns:a16="http://schemas.microsoft.com/office/drawing/2014/main" id="{4818B2F5-5E57-4A8D-9D42-62F5C3ACBAB5}"/>
                  </a:ext>
                </a:extLst>
              </p:cNvPr>
              <p:cNvGraphicFramePr>
                <a:graphicFrameLocks/>
              </p:cNvGraphicFramePr>
              <p:nvPr>
                <p:extLst/>
              </p:nvPr>
            </p:nvGraphicFramePr>
            <p:xfrm>
              <a:off x="3830961" y="3639727"/>
              <a:ext cx="4928616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1"/>
              </a:graphicData>
            </a:graphic>
          </p:graphicFrame>
        </p:grpSp>
        <p:sp>
          <p:nvSpPr>
            <p:cNvPr id="57" name="Rectangle 56">
              <a:extLst>
                <a:ext uri="{FF2B5EF4-FFF2-40B4-BE49-F238E27FC236}">
                  <a16:creationId xmlns:a16="http://schemas.microsoft.com/office/drawing/2014/main" id="{14BAF449-18CA-4B99-B565-4E2EE4EBF2E2}"/>
                </a:ext>
              </a:extLst>
            </p:cNvPr>
            <p:cNvSpPr/>
            <p:nvPr/>
          </p:nvSpPr>
          <p:spPr>
            <a:xfrm>
              <a:off x="3825254" y="771919"/>
              <a:ext cx="298411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l" defTabSz="6858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b</a:t>
              </a:r>
              <a:endPara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58" name="Rectangle 57">
              <a:extLst>
                <a:ext uri="{FF2B5EF4-FFF2-40B4-BE49-F238E27FC236}">
                  <a16:creationId xmlns:a16="http://schemas.microsoft.com/office/drawing/2014/main" id="{4CDB3531-112C-4C3B-BB80-76DD7B0B3006}"/>
                </a:ext>
              </a:extLst>
            </p:cNvPr>
            <p:cNvSpPr/>
            <p:nvPr/>
          </p:nvSpPr>
          <p:spPr>
            <a:xfrm>
              <a:off x="630037" y="764317"/>
              <a:ext cx="312905" cy="36933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6858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a</a:t>
              </a:r>
              <a:endPara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59" name="Rectangle 58">
              <a:extLst>
                <a:ext uri="{FF2B5EF4-FFF2-40B4-BE49-F238E27FC236}">
                  <a16:creationId xmlns:a16="http://schemas.microsoft.com/office/drawing/2014/main" id="{E6A22062-836A-41CA-BC13-A1E23D871055}"/>
                </a:ext>
              </a:extLst>
            </p:cNvPr>
            <p:cNvSpPr/>
            <p:nvPr/>
          </p:nvSpPr>
          <p:spPr>
            <a:xfrm>
              <a:off x="3805822" y="3429000"/>
              <a:ext cx="298411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algn="l" defTabSz="6858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c</a:t>
              </a:r>
              <a:endPara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1650873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7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5</Words>
  <Application>Microsoft Office PowerPoint</Application>
  <PresentationFormat>On-screen Show (4:3)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7_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id Sebti</dc:creator>
  <cp:lastModifiedBy>Said Sebti</cp:lastModifiedBy>
  <cp:revision>1</cp:revision>
  <dcterms:created xsi:type="dcterms:W3CDTF">2023-10-30T19:48:56Z</dcterms:created>
  <dcterms:modified xsi:type="dcterms:W3CDTF">2023-10-30T19:49:25Z</dcterms:modified>
</cp:coreProperties>
</file>